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101" d="100"/>
          <a:sy n="101" d="100"/>
        </p:scale>
        <p:origin x="126" y="3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hutton-my.sharepoint.com/personal/ray_campbell_hutton_ac_uk/Documents/CPC%20leakage%20data%20normalised%20and%20finalised%2012_5_21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5.6459937372178637E-2"/>
          <c:y val="3.2342746994289198E-2"/>
          <c:w val="0.92896126255996381"/>
          <c:h val="0.7589793953318557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CPC leakage data normalised and finalised 12_5_21.xlsx]12_5_21'!$I$60</c:f>
              <c:strCache>
                <c:ptCount val="1"/>
                <c:pt idx="0">
                  <c:v>20°C</c:v>
                </c:pt>
              </c:strCache>
            </c:strRef>
          </c:tx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CPC leakage data normalised and finalised 12_5_21.xlsx]5_5_21'!$C$37:$C$68</c:f>
                <c:numCache>
                  <c:formatCode>General</c:formatCode>
                  <c:ptCount val="32"/>
                  <c:pt idx="0">
                    <c:v>1.3996440545189726</c:v>
                  </c:pt>
                  <c:pt idx="1">
                    <c:v>0.34592379048304694</c:v>
                  </c:pt>
                  <c:pt idx="2">
                    <c:v>0.3874173415971765</c:v>
                  </c:pt>
                  <c:pt idx="3">
                    <c:v>0.46628172598560658</c:v>
                  </c:pt>
                  <c:pt idx="4">
                    <c:v>0.45868396982371729</c:v>
                  </c:pt>
                  <c:pt idx="5">
                    <c:v>0.57916185757578831</c:v>
                  </c:pt>
                  <c:pt idx="6">
                    <c:v>0.80020474128382735</c:v>
                  </c:pt>
                  <c:pt idx="7">
                    <c:v>0.15236568792920754</c:v>
                  </c:pt>
                  <c:pt idx="8">
                    <c:v>0.3608052502936952</c:v>
                  </c:pt>
                  <c:pt idx="9">
                    <c:v>0.41328730076955178</c:v>
                  </c:pt>
                  <c:pt idx="10">
                    <c:v>0.34677493038139495</c:v>
                  </c:pt>
                  <c:pt idx="11">
                    <c:v>1.3391440545189739</c:v>
                  </c:pt>
                  <c:pt idx="12">
                    <c:v>0.30512207864748359</c:v>
                  </c:pt>
                  <c:pt idx="13">
                    <c:v>0.78334442177064967</c:v>
                  </c:pt>
                  <c:pt idx="14">
                    <c:v>0.62165097485599663</c:v>
                  </c:pt>
                  <c:pt idx="15">
                    <c:v>0.38017889097912894</c:v>
                  </c:pt>
                  <c:pt idx="16">
                    <c:v>0.42653371352320851</c:v>
                  </c:pt>
                  <c:pt idx="17">
                    <c:v>0.49622059435911303</c:v>
                  </c:pt>
                  <c:pt idx="18">
                    <c:v>0.23328969811391992</c:v>
                  </c:pt>
                  <c:pt idx="19">
                    <c:v>0.31501045050840287</c:v>
                  </c:pt>
                  <c:pt idx="20">
                    <c:v>0.21751112172645026</c:v>
                  </c:pt>
                  <c:pt idx="21">
                    <c:v>0.27078603564021791</c:v>
                  </c:pt>
                  <c:pt idx="22">
                    <c:v>0.52025255651359747</c:v>
                  </c:pt>
                  <c:pt idx="23">
                    <c:v>0.5299143932799939</c:v>
                  </c:pt>
                  <c:pt idx="24">
                    <c:v>0.33272599073482778</c:v>
                  </c:pt>
                  <c:pt idx="25">
                    <c:v>0.53015700560907209</c:v>
                  </c:pt>
                  <c:pt idx="26">
                    <c:v>0.48943458046679833</c:v>
                  </c:pt>
                  <c:pt idx="27">
                    <c:v>0.4720462436845087</c:v>
                  </c:pt>
                  <c:pt idx="28">
                    <c:v>0.90913729009699307</c:v>
                  </c:pt>
                  <c:pt idx="29">
                    <c:v>0.64242658059375046</c:v>
                  </c:pt>
                  <c:pt idx="30">
                    <c:v>0.25298103791286752</c:v>
                  </c:pt>
                  <c:pt idx="31">
                    <c:v>0.85413729009699202</c:v>
                  </c:pt>
                </c:numCache>
              </c:numRef>
            </c:plus>
            <c:minus>
              <c:numRef>
                <c:f>'[CPC leakage data normalised and finalised 12_5_21.xlsx]5_5_21'!$C$37:$C$68</c:f>
                <c:numCache>
                  <c:formatCode>General</c:formatCode>
                  <c:ptCount val="32"/>
                  <c:pt idx="0">
                    <c:v>1.3996440545189726</c:v>
                  </c:pt>
                  <c:pt idx="1">
                    <c:v>0.34592379048304694</c:v>
                  </c:pt>
                  <c:pt idx="2">
                    <c:v>0.3874173415971765</c:v>
                  </c:pt>
                  <c:pt idx="3">
                    <c:v>0.46628172598560658</c:v>
                  </c:pt>
                  <c:pt idx="4">
                    <c:v>0.45868396982371729</c:v>
                  </c:pt>
                  <c:pt idx="5">
                    <c:v>0.57916185757578831</c:v>
                  </c:pt>
                  <c:pt idx="6">
                    <c:v>0.80020474128382735</c:v>
                  </c:pt>
                  <c:pt idx="7">
                    <c:v>0.15236568792920754</c:v>
                  </c:pt>
                  <c:pt idx="8">
                    <c:v>0.3608052502936952</c:v>
                  </c:pt>
                  <c:pt idx="9">
                    <c:v>0.41328730076955178</c:v>
                  </c:pt>
                  <c:pt idx="10">
                    <c:v>0.34677493038139495</c:v>
                  </c:pt>
                  <c:pt idx="11">
                    <c:v>1.3391440545189739</c:v>
                  </c:pt>
                  <c:pt idx="12">
                    <c:v>0.30512207864748359</c:v>
                  </c:pt>
                  <c:pt idx="13">
                    <c:v>0.78334442177064967</c:v>
                  </c:pt>
                  <c:pt idx="14">
                    <c:v>0.62165097485599663</c:v>
                  </c:pt>
                  <c:pt idx="15">
                    <c:v>0.38017889097912894</c:v>
                  </c:pt>
                  <c:pt idx="16">
                    <c:v>0.42653371352320851</c:v>
                  </c:pt>
                  <c:pt idx="17">
                    <c:v>0.49622059435911303</c:v>
                  </c:pt>
                  <c:pt idx="18">
                    <c:v>0.23328969811391992</c:v>
                  </c:pt>
                  <c:pt idx="19">
                    <c:v>0.31501045050840287</c:v>
                  </c:pt>
                  <c:pt idx="20">
                    <c:v>0.21751112172645026</c:v>
                  </c:pt>
                  <c:pt idx="21">
                    <c:v>0.27078603564021791</c:v>
                  </c:pt>
                  <c:pt idx="22">
                    <c:v>0.52025255651359747</c:v>
                  </c:pt>
                  <c:pt idx="23">
                    <c:v>0.5299143932799939</c:v>
                  </c:pt>
                  <c:pt idx="24">
                    <c:v>0.33272599073482778</c:v>
                  </c:pt>
                  <c:pt idx="25">
                    <c:v>0.53015700560907209</c:v>
                  </c:pt>
                  <c:pt idx="26">
                    <c:v>0.48943458046679833</c:v>
                  </c:pt>
                  <c:pt idx="27">
                    <c:v>0.4720462436845087</c:v>
                  </c:pt>
                  <c:pt idx="28">
                    <c:v>0.90913729009699307</c:v>
                  </c:pt>
                  <c:pt idx="29">
                    <c:v>0.64242658059375046</c:v>
                  </c:pt>
                  <c:pt idx="30">
                    <c:v>0.25298103791286752</c:v>
                  </c:pt>
                  <c:pt idx="31">
                    <c:v>0.8541372900969920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[CPC leakage data normalised and finalised 12_5_21.xlsx]12_5_21'!$A$37,'[CPC leakage data normalised and finalised 12_5_21.xlsx]12_5_21'!$A$39:$A$63,'[CPC leakage data normalised and finalised 12_5_21.xlsx]12_5_21'!$A$65</c:f>
              <c:strCache>
                <c:ptCount val="27"/>
                <c:pt idx="0">
                  <c:v>PNT 3559</c:v>
                </c:pt>
                <c:pt idx="1">
                  <c:v>TBR 5639 </c:v>
                </c:pt>
                <c:pt idx="2">
                  <c:v>TOR 7702 </c:v>
                </c:pt>
                <c:pt idx="3">
                  <c:v>VER 7630</c:v>
                </c:pt>
                <c:pt idx="4">
                  <c:v>SPH 7607</c:v>
                </c:pt>
                <c:pt idx="5">
                  <c:v>ADG 7540 </c:v>
                </c:pt>
                <c:pt idx="6">
                  <c:v>SPL 2730</c:v>
                </c:pt>
                <c:pt idx="7">
                  <c:v>JAM 7653</c:v>
                </c:pt>
                <c:pt idx="8">
                  <c:v>PLT 7087</c:v>
                </c:pt>
                <c:pt idx="9">
                  <c:v>AGF 2684</c:v>
                </c:pt>
                <c:pt idx="10">
                  <c:v>ADG 1491 </c:v>
                </c:pt>
                <c:pt idx="11">
                  <c:v>NRS 7286</c:v>
                </c:pt>
                <c:pt idx="12">
                  <c:v>ADG 1061 </c:v>
                </c:pt>
                <c:pt idx="13">
                  <c:v>DMS 1355</c:v>
                </c:pt>
                <c:pt idx="14">
                  <c:v>VRN 2733</c:v>
                </c:pt>
                <c:pt idx="15">
                  <c:v>BUK 7746</c:v>
                </c:pt>
                <c:pt idx="16">
                  <c:v>PHU 4088 </c:v>
                </c:pt>
                <c:pt idx="17">
                  <c:v>ALL 7004</c:v>
                </c:pt>
                <c:pt idx="18">
                  <c:v>MLT 7699</c:v>
                </c:pt>
                <c:pt idx="19">
                  <c:v>CAN 7622</c:v>
                </c:pt>
                <c:pt idx="20">
                  <c:v>TBR 5643</c:v>
                </c:pt>
                <c:pt idx="21">
                  <c:v>Desiree WT</c:v>
                </c:pt>
                <c:pt idx="22">
                  <c:v>IFO 2477</c:v>
                </c:pt>
                <c:pt idx="23">
                  <c:v>RAP 7691</c:v>
                </c:pt>
                <c:pt idx="24">
                  <c:v>CRC QUM</c:v>
                </c:pt>
                <c:pt idx="25">
                  <c:v>VIO 7128</c:v>
                </c:pt>
                <c:pt idx="26">
                  <c:v>BLV 3517</c:v>
                </c:pt>
              </c:strCache>
            </c:strRef>
          </c:cat>
          <c:val>
            <c:numRef>
              <c:f>'[CPC leakage data normalised and finalised 12_5_21.xlsx]12_5_21'!$B$37,'[CPC leakage data normalised and finalised 12_5_21.xlsx]12_5_21'!$B$39:$B$63,'[CPC leakage data normalised and finalised 12_5_21.xlsx]12_5_21'!$B$65</c:f>
              <c:numCache>
                <c:formatCode>0.0</c:formatCode>
                <c:ptCount val="27"/>
                <c:pt idx="0">
                  <c:v>4.0999999999999996</c:v>
                </c:pt>
                <c:pt idx="1">
                  <c:v>4.3159231283832291</c:v>
                </c:pt>
                <c:pt idx="2">
                  <c:v>5.9279879896021965</c:v>
                </c:pt>
                <c:pt idx="3">
                  <c:v>7.9569462575793981</c:v>
                </c:pt>
                <c:pt idx="4">
                  <c:v>9.1999999999999993</c:v>
                </c:pt>
                <c:pt idx="5">
                  <c:v>4.9739152584949844</c:v>
                </c:pt>
                <c:pt idx="6">
                  <c:v>6.7787918736886432</c:v>
                </c:pt>
                <c:pt idx="7">
                  <c:v>11.549999999999999</c:v>
                </c:pt>
                <c:pt idx="8">
                  <c:v>4.9029838498066107</c:v>
                </c:pt>
                <c:pt idx="9">
                  <c:v>4.6782240851204318</c:v>
                </c:pt>
                <c:pt idx="10">
                  <c:v>5.6171607019980314</c:v>
                </c:pt>
                <c:pt idx="11">
                  <c:v>4.4079111231741104</c:v>
                </c:pt>
                <c:pt idx="12">
                  <c:v>5.2550852823571566</c:v>
                </c:pt>
                <c:pt idx="13">
                  <c:v>4.0993078307052899</c:v>
                </c:pt>
                <c:pt idx="14">
                  <c:v>4.5029770174443655</c:v>
                </c:pt>
                <c:pt idx="15">
                  <c:v>5.2928671983979321</c:v>
                </c:pt>
                <c:pt idx="16">
                  <c:v>4.4070711303518904</c:v>
                </c:pt>
                <c:pt idx="17">
                  <c:v>4.7430746332161027</c:v>
                </c:pt>
                <c:pt idx="18">
                  <c:v>3.8244291185886907</c:v>
                </c:pt>
                <c:pt idx="19">
                  <c:v>4.3173806609547114</c:v>
                </c:pt>
                <c:pt idx="20">
                  <c:v>5.1644870980314277</c:v>
                </c:pt>
                <c:pt idx="21">
                  <c:v>4.7601367800799057</c:v>
                </c:pt>
                <c:pt idx="22">
                  <c:v>10.25</c:v>
                </c:pt>
                <c:pt idx="23">
                  <c:v>4.7040366627420198</c:v>
                </c:pt>
                <c:pt idx="24">
                  <c:v>6.54212818074501</c:v>
                </c:pt>
                <c:pt idx="25">
                  <c:v>6.9135</c:v>
                </c:pt>
                <c:pt idx="26">
                  <c:v>9.80000000000000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DAD-4BF8-A02B-6C537846C86E}"/>
            </c:ext>
          </c:extLst>
        </c:ser>
        <c:ser>
          <c:idx val="1"/>
          <c:order val="1"/>
          <c:tx>
            <c:strRef>
              <c:f>'[CPC leakage data normalised and finalised 12_5_21.xlsx]12_5_21'!$I$61</c:f>
              <c:strCache>
                <c:ptCount val="1"/>
                <c:pt idx="0">
                  <c:v>40°C</c:v>
                </c:pt>
              </c:strCache>
            </c:strRef>
          </c:tx>
          <c:spPr>
            <a:solidFill>
              <a:schemeClr val="accent2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CPC leakage data normalised and finalised 12_5_21.xlsx]5_5_21'!$G$37:$G$68</c:f>
                <c:numCache>
                  <c:formatCode>General</c:formatCode>
                  <c:ptCount val="32"/>
                  <c:pt idx="0">
                    <c:v>1.5329486002730759</c:v>
                  </c:pt>
                  <c:pt idx="1">
                    <c:v>0.66648737856726181</c:v>
                  </c:pt>
                  <c:pt idx="2">
                    <c:v>0.57794148992767758</c:v>
                  </c:pt>
                  <c:pt idx="3">
                    <c:v>1.752214803549162</c:v>
                  </c:pt>
                  <c:pt idx="4">
                    <c:v>0.71481793087577905</c:v>
                  </c:pt>
                  <c:pt idx="5">
                    <c:v>0.44821864300873465</c:v>
                  </c:pt>
                  <c:pt idx="6">
                    <c:v>1.444545190676743</c:v>
                  </c:pt>
                  <c:pt idx="7">
                    <c:v>1.2579368408907188</c:v>
                  </c:pt>
                  <c:pt idx="8">
                    <c:v>1.3275566570352688</c:v>
                  </c:pt>
                  <c:pt idx="9">
                    <c:v>1.8103968421082048</c:v>
                  </c:pt>
                  <c:pt idx="10">
                    <c:v>1.5845106003365386</c:v>
                  </c:pt>
                  <c:pt idx="11">
                    <c:v>1.3712486002730746</c:v>
                  </c:pt>
                  <c:pt idx="12">
                    <c:v>2.4841642417229277</c:v>
                  </c:pt>
                  <c:pt idx="13">
                    <c:v>0.75362910506628533</c:v>
                  </c:pt>
                  <c:pt idx="14">
                    <c:v>3.2650516883877523</c:v>
                  </c:pt>
                  <c:pt idx="15">
                    <c:v>0.7486198547204872</c:v>
                  </c:pt>
                  <c:pt idx="16">
                    <c:v>4.1064819598507558</c:v>
                  </c:pt>
                  <c:pt idx="17">
                    <c:v>3.4608911615209283</c:v>
                  </c:pt>
                  <c:pt idx="18">
                    <c:v>1.7522344624553094</c:v>
                  </c:pt>
                  <c:pt idx="19">
                    <c:v>3.9993503104489885</c:v>
                  </c:pt>
                  <c:pt idx="20">
                    <c:v>2.8665178608727158</c:v>
                  </c:pt>
                  <c:pt idx="21">
                    <c:v>4.3946144669947556</c:v>
                  </c:pt>
                  <c:pt idx="22">
                    <c:v>3.6009561223049538</c:v>
                  </c:pt>
                  <c:pt idx="23">
                    <c:v>2.5853765996279918</c:v>
                  </c:pt>
                  <c:pt idx="24">
                    <c:v>3.1239645086478816</c:v>
                  </c:pt>
                  <c:pt idx="25">
                    <c:v>2.376905024336093</c:v>
                  </c:pt>
                  <c:pt idx="26">
                    <c:v>6.4815899506089236</c:v>
                  </c:pt>
                  <c:pt idx="27">
                    <c:v>3.5713389070643009</c:v>
                  </c:pt>
                  <c:pt idx="28">
                    <c:v>8.1791287353592743</c:v>
                  </c:pt>
                  <c:pt idx="29">
                    <c:v>8.0597012308959304</c:v>
                  </c:pt>
                  <c:pt idx="30">
                    <c:v>3.6713654685569841</c:v>
                  </c:pt>
                  <c:pt idx="31">
                    <c:v>8.1098287353592742</c:v>
                  </c:pt>
                </c:numCache>
              </c:numRef>
            </c:plus>
            <c:minus>
              <c:numRef>
                <c:f>'[CPC leakage data normalised and finalised 12_5_21.xlsx]5_5_21'!$G$37:$G$68</c:f>
                <c:numCache>
                  <c:formatCode>General</c:formatCode>
                  <c:ptCount val="32"/>
                  <c:pt idx="0">
                    <c:v>1.5329486002730759</c:v>
                  </c:pt>
                  <c:pt idx="1">
                    <c:v>0.66648737856726181</c:v>
                  </c:pt>
                  <c:pt idx="2">
                    <c:v>0.57794148992767758</c:v>
                  </c:pt>
                  <c:pt idx="3">
                    <c:v>1.752214803549162</c:v>
                  </c:pt>
                  <c:pt idx="4">
                    <c:v>0.71481793087577905</c:v>
                  </c:pt>
                  <c:pt idx="5">
                    <c:v>0.44821864300873465</c:v>
                  </c:pt>
                  <c:pt idx="6">
                    <c:v>1.444545190676743</c:v>
                  </c:pt>
                  <c:pt idx="7">
                    <c:v>1.2579368408907188</c:v>
                  </c:pt>
                  <c:pt idx="8">
                    <c:v>1.3275566570352688</c:v>
                  </c:pt>
                  <c:pt idx="9">
                    <c:v>1.8103968421082048</c:v>
                  </c:pt>
                  <c:pt idx="10">
                    <c:v>1.5845106003365386</c:v>
                  </c:pt>
                  <c:pt idx="11">
                    <c:v>1.3712486002730746</c:v>
                  </c:pt>
                  <c:pt idx="12">
                    <c:v>2.4841642417229277</c:v>
                  </c:pt>
                  <c:pt idx="13">
                    <c:v>0.75362910506628533</c:v>
                  </c:pt>
                  <c:pt idx="14">
                    <c:v>3.2650516883877523</c:v>
                  </c:pt>
                  <c:pt idx="15">
                    <c:v>0.7486198547204872</c:v>
                  </c:pt>
                  <c:pt idx="16">
                    <c:v>4.1064819598507558</c:v>
                  </c:pt>
                  <c:pt idx="17">
                    <c:v>3.4608911615209283</c:v>
                  </c:pt>
                  <c:pt idx="18">
                    <c:v>1.7522344624553094</c:v>
                  </c:pt>
                  <c:pt idx="19">
                    <c:v>3.9993503104489885</c:v>
                  </c:pt>
                  <c:pt idx="20">
                    <c:v>2.8665178608727158</c:v>
                  </c:pt>
                  <c:pt idx="21">
                    <c:v>4.3946144669947556</c:v>
                  </c:pt>
                  <c:pt idx="22">
                    <c:v>3.6009561223049538</c:v>
                  </c:pt>
                  <c:pt idx="23">
                    <c:v>2.5853765996279918</c:v>
                  </c:pt>
                  <c:pt idx="24">
                    <c:v>3.1239645086478816</c:v>
                  </c:pt>
                  <c:pt idx="25">
                    <c:v>2.376905024336093</c:v>
                  </c:pt>
                  <c:pt idx="26">
                    <c:v>6.4815899506089236</c:v>
                  </c:pt>
                  <c:pt idx="27">
                    <c:v>3.5713389070643009</c:v>
                  </c:pt>
                  <c:pt idx="28">
                    <c:v>8.1791287353592743</c:v>
                  </c:pt>
                  <c:pt idx="29">
                    <c:v>8.0597012308959304</c:v>
                  </c:pt>
                  <c:pt idx="30">
                    <c:v>3.6713654685569841</c:v>
                  </c:pt>
                  <c:pt idx="31">
                    <c:v>8.109828735359274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[CPC leakage data normalised and finalised 12_5_21.xlsx]12_5_21'!$A$37,'[CPC leakage data normalised and finalised 12_5_21.xlsx]12_5_21'!$A$39:$A$63,'[CPC leakage data normalised and finalised 12_5_21.xlsx]12_5_21'!$A$65</c:f>
              <c:strCache>
                <c:ptCount val="27"/>
                <c:pt idx="0">
                  <c:v>PNT 3559</c:v>
                </c:pt>
                <c:pt idx="1">
                  <c:v>TBR 5639 </c:v>
                </c:pt>
                <c:pt idx="2">
                  <c:v>TOR 7702 </c:v>
                </c:pt>
                <c:pt idx="3">
                  <c:v>VER 7630</c:v>
                </c:pt>
                <c:pt idx="4">
                  <c:v>SPH 7607</c:v>
                </c:pt>
                <c:pt idx="5">
                  <c:v>ADG 7540 </c:v>
                </c:pt>
                <c:pt idx="6">
                  <c:v>SPL 2730</c:v>
                </c:pt>
                <c:pt idx="7">
                  <c:v>JAM 7653</c:v>
                </c:pt>
                <c:pt idx="8">
                  <c:v>PLT 7087</c:v>
                </c:pt>
                <c:pt idx="9">
                  <c:v>AGF 2684</c:v>
                </c:pt>
                <c:pt idx="10">
                  <c:v>ADG 1491 </c:v>
                </c:pt>
                <c:pt idx="11">
                  <c:v>NRS 7286</c:v>
                </c:pt>
                <c:pt idx="12">
                  <c:v>ADG 1061 </c:v>
                </c:pt>
                <c:pt idx="13">
                  <c:v>DMS 1355</c:v>
                </c:pt>
                <c:pt idx="14">
                  <c:v>VRN 2733</c:v>
                </c:pt>
                <c:pt idx="15">
                  <c:v>BUK 7746</c:v>
                </c:pt>
                <c:pt idx="16">
                  <c:v>PHU 4088 </c:v>
                </c:pt>
                <c:pt idx="17">
                  <c:v>ALL 7004</c:v>
                </c:pt>
                <c:pt idx="18">
                  <c:v>MLT 7699</c:v>
                </c:pt>
                <c:pt idx="19">
                  <c:v>CAN 7622</c:v>
                </c:pt>
                <c:pt idx="20">
                  <c:v>TBR 5643</c:v>
                </c:pt>
                <c:pt idx="21">
                  <c:v>Desiree WT</c:v>
                </c:pt>
                <c:pt idx="22">
                  <c:v>IFO 2477</c:v>
                </c:pt>
                <c:pt idx="23">
                  <c:v>RAP 7691</c:v>
                </c:pt>
                <c:pt idx="24">
                  <c:v>CRC QUM</c:v>
                </c:pt>
                <c:pt idx="25">
                  <c:v>VIO 7128</c:v>
                </c:pt>
                <c:pt idx="26">
                  <c:v>BLV 3517</c:v>
                </c:pt>
              </c:strCache>
            </c:strRef>
          </c:cat>
          <c:val>
            <c:numRef>
              <c:f>'[CPC leakage data normalised and finalised 12_5_21.xlsx]12_5_21'!$E$37,'[CPC leakage data normalised and finalised 12_5_21.xlsx]12_5_21'!$E$39:$E$63,'[CPC leakage data normalised and finalised 12_5_21.xlsx]12_5_21'!$E$65</c:f>
              <c:numCache>
                <c:formatCode>0.0</c:formatCode>
                <c:ptCount val="27"/>
                <c:pt idx="0">
                  <c:v>5.3169743829129628</c:v>
                </c:pt>
                <c:pt idx="1">
                  <c:v>8.4030648890602802</c:v>
                </c:pt>
                <c:pt idx="2">
                  <c:v>9.0145743546715753</c:v>
                </c:pt>
                <c:pt idx="3">
                  <c:v>9.767534097110028</c:v>
                </c:pt>
                <c:pt idx="4">
                  <c:v>11.4</c:v>
                </c:pt>
                <c:pt idx="5">
                  <c:v>13.549866378745772</c:v>
                </c:pt>
                <c:pt idx="6">
                  <c:v>13.78975258952722</c:v>
                </c:pt>
                <c:pt idx="7">
                  <c:v>14.63</c:v>
                </c:pt>
                <c:pt idx="8">
                  <c:v>15.921036134543709</c:v>
                </c:pt>
                <c:pt idx="9">
                  <c:v>16.243196532007701</c:v>
                </c:pt>
                <c:pt idx="10">
                  <c:v>17.692932849255133</c:v>
                </c:pt>
                <c:pt idx="11">
                  <c:v>18.049646260172572</c:v>
                </c:pt>
                <c:pt idx="12">
                  <c:v>28.048392085501714</c:v>
                </c:pt>
                <c:pt idx="13">
                  <c:v>28.597322869534366</c:v>
                </c:pt>
                <c:pt idx="14">
                  <c:v>30.971642622155571</c:v>
                </c:pt>
                <c:pt idx="15">
                  <c:v>31.828562657206852</c:v>
                </c:pt>
                <c:pt idx="16">
                  <c:v>33.996079577397651</c:v>
                </c:pt>
                <c:pt idx="17">
                  <c:v>35.105998992818151</c:v>
                </c:pt>
                <c:pt idx="18">
                  <c:v>35.165128402833318</c:v>
                </c:pt>
                <c:pt idx="19">
                  <c:v>39.240041928721176</c:v>
                </c:pt>
                <c:pt idx="20">
                  <c:v>40.584132071808405</c:v>
                </c:pt>
                <c:pt idx="21">
                  <c:v>42.305985843963576</c:v>
                </c:pt>
                <c:pt idx="22">
                  <c:v>46.3</c:v>
                </c:pt>
                <c:pt idx="23">
                  <c:v>46.56852422048965</c:v>
                </c:pt>
                <c:pt idx="24">
                  <c:v>49.70954579632371</c:v>
                </c:pt>
                <c:pt idx="25">
                  <c:v>59.813600000000001</c:v>
                </c:pt>
                <c:pt idx="26">
                  <c:v>65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DAD-4BF8-A02B-6C537846C86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47800368"/>
        <c:axId val="847801680"/>
      </c:barChart>
      <c:catAx>
        <c:axId val="8478003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47801680"/>
        <c:crosses val="autoZero"/>
        <c:auto val="1"/>
        <c:lblAlgn val="ctr"/>
        <c:lblOffset val="100"/>
        <c:noMultiLvlLbl val="0"/>
      </c:catAx>
      <c:valAx>
        <c:axId val="84780168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200" b="1" i="0" baseline="0">
                    <a:solidFill>
                      <a:schemeClr val="tx1"/>
                    </a:solidFill>
                  </a:rPr>
                  <a:t>% Membrane damag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" sourceLinked="1"/>
        <c:majorTickMark val="none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4780036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5.8020780189361576E-2"/>
          <c:y val="5.050885999109591E-2"/>
          <c:w val="8.9520203417195798E-2"/>
          <c:h val="6.395112610406954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DD9829-A6FF-421F-B85E-3F5AEB46EBC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551788A-125E-4D83-865B-BCBFDA4FDF6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B8A954-EB73-4050-80B3-59D75CFD57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A3F440-D05C-4332-AD14-1797F99F6CA7}" type="datetimeFigureOut">
              <a:rPr lang="en-GB" smtClean="0"/>
              <a:t>02/07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B68EF1-433B-4ABB-AA33-DE83163BE4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24FFC7-C494-4DD3-8023-A69CED329A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B7B98-D292-47E4-8CB0-5E678618DC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88136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A7E59E-8E2B-492A-8E11-A8BB0CB8BC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D26AF4B-7A9E-4B7A-A0F2-34805D9C39F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44E3D3-177F-4AFF-98B2-111BCCF965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A3F440-D05C-4332-AD14-1797F99F6CA7}" type="datetimeFigureOut">
              <a:rPr lang="en-GB" smtClean="0"/>
              <a:t>02/07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E5A29F-7068-4492-A724-37960963E8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5C7081-C4D4-4AFE-B19F-DB2614CCD2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B7B98-D292-47E4-8CB0-5E678618DC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71566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9BD260A-BB76-4F84-972B-0526BEA1410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4C358E5-032D-4D92-B132-6018BBC5AC4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8A5581-B59A-402C-94E2-CE99ACDCFD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A3F440-D05C-4332-AD14-1797F99F6CA7}" type="datetimeFigureOut">
              <a:rPr lang="en-GB" smtClean="0"/>
              <a:t>02/07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608A55-BB2A-43A3-BFB5-589EDA0451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43B706-2319-4A85-A1D3-E98FC60467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B7B98-D292-47E4-8CB0-5E678618DC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41749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6441A4-422D-4083-B607-AE542418CE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67B0508-C32D-4F13-AFC9-35C3793800C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498E6A-003B-47F9-A3DF-7B7342572E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A3F440-D05C-4332-AD14-1797F99F6CA7}" type="datetimeFigureOut">
              <a:rPr lang="en-GB" smtClean="0"/>
              <a:t>02/07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9FB08D-3F2B-48FB-B51A-C3FA6BD842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B28B01-1921-421A-8D67-62D055917E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B7B98-D292-47E4-8CB0-5E678618DC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81993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E85430-DE60-4E50-AFE6-AC0B2196CE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BA8854C-C568-473F-9E2D-71421C4CE1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D25BC5-E21C-4CD8-967A-D583323BB6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A3F440-D05C-4332-AD14-1797F99F6CA7}" type="datetimeFigureOut">
              <a:rPr lang="en-GB" smtClean="0"/>
              <a:t>02/07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8337AB-C78F-4C89-9ABE-65B599FCFE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69C57C0-522C-42A8-8D41-43D7F8840C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B7B98-D292-47E4-8CB0-5E678618DC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60834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B7F0AA-5F10-42A4-8AF0-FE1A6A270F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E346CE0-71C7-44C6-ABCC-1F92E1F9F89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72B8415-0325-4761-9C02-BA8C7C79FBF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45E88F7-462B-472B-89C5-12CB923B4C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A3F440-D05C-4332-AD14-1797F99F6CA7}" type="datetimeFigureOut">
              <a:rPr lang="en-GB" smtClean="0"/>
              <a:t>02/07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B5404FA-1D2B-4D14-9D9F-DCE9E0A86F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AB79D0B-F826-4B88-B069-D98A3C863F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B7B98-D292-47E4-8CB0-5E678618DC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99184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636A2D-CEFE-4353-A726-0BF75CF416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8056BBB-F269-4F58-8A6F-A234CC7918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81E1B6B-2D8B-44F2-B957-89D1AEC232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3B38116-BEBB-4699-BC09-07E4F1E6285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6E8FF40-14D1-4F67-B511-B2055D5E7F7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2D5AF0A-B2B6-4655-BC85-96C9B8B947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A3F440-D05C-4332-AD14-1797F99F6CA7}" type="datetimeFigureOut">
              <a:rPr lang="en-GB" smtClean="0"/>
              <a:t>02/07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E187E67-4777-4003-AD32-CDED718242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9E7C7C7-3437-47F1-8189-C42269EFAF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B7B98-D292-47E4-8CB0-5E678618DC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19965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19554F-5117-4E7C-B6FA-23222EBE6B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D120C32-CA40-4A89-9AFA-45AD1D01B4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A3F440-D05C-4332-AD14-1797F99F6CA7}" type="datetimeFigureOut">
              <a:rPr lang="en-GB" smtClean="0"/>
              <a:t>02/07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CDDBC02-7953-4855-BD65-60A4ED73BC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3C073F8-134A-4C02-BE1E-E9500D434C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B7B98-D292-47E4-8CB0-5E678618DC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03856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8AEA013-FD98-4AEE-9B62-06683022A7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A3F440-D05C-4332-AD14-1797F99F6CA7}" type="datetimeFigureOut">
              <a:rPr lang="en-GB" smtClean="0"/>
              <a:t>02/07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24AE61B-260E-48C3-9388-4D01F333C1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5B356EC-BAB1-40E6-BACA-6DFF741B3C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B7B98-D292-47E4-8CB0-5E678618DC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83634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59F909-F1B5-4146-A31C-A1A49F38B8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3538FD4-3835-4F8B-8D8F-147B0E7DCF6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7246DDB-E4F0-4F92-B118-016C459052B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E284532-7BDB-4167-9E19-0E79248450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A3F440-D05C-4332-AD14-1797F99F6CA7}" type="datetimeFigureOut">
              <a:rPr lang="en-GB" smtClean="0"/>
              <a:t>02/07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8AD32EC-63EF-476F-A9F4-C7135E2D98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E561ADE-2022-401B-AEC1-AFB1164C49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B7B98-D292-47E4-8CB0-5E678618DC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36508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9FFC96-9B9D-403F-A196-D5AF99508B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BF2C5C5-ACE7-40DD-AA70-A731F855706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0789E8B-3027-4B9D-8F4A-97C0A9BE91C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D1A50AF-2310-4C8F-855C-A1D3C943AF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A3F440-D05C-4332-AD14-1797F99F6CA7}" type="datetimeFigureOut">
              <a:rPr lang="en-GB" smtClean="0"/>
              <a:t>02/07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FBF6B69-21B4-471C-A111-CAE73F7AF7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59AFDB-6B75-4024-A29B-72A5682910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B7B98-D292-47E4-8CB0-5E678618DC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76290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C248BB3-1D78-48A2-B444-C6779347B5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23A0D79-122B-4238-9BBB-12E110239C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3EB932-5250-4223-97FC-F956BBE8017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A3F440-D05C-4332-AD14-1797F99F6CA7}" type="datetimeFigureOut">
              <a:rPr lang="en-GB" smtClean="0"/>
              <a:t>02/07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292D5D-2D2A-4815-9D74-E9C250C913D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F202C4-88AA-4C84-87B3-E35E61A64A0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0B7B98-D292-47E4-8CB0-5E678618DC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72858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6C48954A-C7C7-49EB-B826-E681811F041D}"/>
              </a:ext>
            </a:extLst>
          </p:cNvPr>
          <p:cNvGraphicFramePr>
            <a:graphicFrameLocks/>
          </p:cNvGraphicFramePr>
          <p:nvPr/>
        </p:nvGraphicFramePr>
        <p:xfrm>
          <a:off x="42141" y="1328593"/>
          <a:ext cx="12107718" cy="42008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6871132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3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ymond Campbell</dc:creator>
  <cp:lastModifiedBy>Mark Taylor</cp:lastModifiedBy>
  <cp:revision>2</cp:revision>
  <dcterms:created xsi:type="dcterms:W3CDTF">2021-05-12T10:46:26Z</dcterms:created>
  <dcterms:modified xsi:type="dcterms:W3CDTF">2021-07-02T07:27:15Z</dcterms:modified>
</cp:coreProperties>
</file>